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8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>
        <p:scale>
          <a:sx n="141" d="100"/>
          <a:sy n="141" d="100"/>
        </p:scale>
        <p:origin x="2064" y="-3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7C7C01A-2F29-F963-ACD2-6FC5D803CF6F}"/>
              </a:ext>
            </a:extLst>
          </p:cNvPr>
          <p:cNvSpPr txBox="1"/>
          <p:nvPr/>
        </p:nvSpPr>
        <p:spPr>
          <a:xfrm>
            <a:off x="0" y="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31EBA02-B6D8-7E71-50D1-C017534D24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921" t="10097" r="15302" b="10240"/>
          <a:stretch/>
        </p:blipFill>
        <p:spPr>
          <a:xfrm>
            <a:off x="696685" y="215428"/>
            <a:ext cx="4237873" cy="60832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823F407-2BEB-6873-0887-6A490BA720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75" t="10288" r="10096" b="61725"/>
          <a:stretch/>
        </p:blipFill>
        <p:spPr>
          <a:xfrm>
            <a:off x="696685" y="6539572"/>
            <a:ext cx="4348011" cy="205478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647E89B-63B9-67D1-ABFB-E41571394517}"/>
              </a:ext>
            </a:extLst>
          </p:cNvPr>
          <p:cNvSpPr txBox="1"/>
          <p:nvPr/>
        </p:nvSpPr>
        <p:spPr>
          <a:xfrm>
            <a:off x="374469" y="7009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81F6FC-E700-E25F-0DA4-64414D2D127C}"/>
              </a:ext>
            </a:extLst>
          </p:cNvPr>
          <p:cNvSpPr txBox="1"/>
          <p:nvPr/>
        </p:nvSpPr>
        <p:spPr>
          <a:xfrm>
            <a:off x="374469" y="279944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D9BCD31-7A92-233D-FF34-A1217B8DBEC3}"/>
              </a:ext>
            </a:extLst>
          </p:cNvPr>
          <p:cNvSpPr txBox="1"/>
          <p:nvPr/>
        </p:nvSpPr>
        <p:spPr>
          <a:xfrm>
            <a:off x="374469" y="485180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D53DFE1-1E38-549A-1C54-C4FC1D37EC1A}"/>
              </a:ext>
            </a:extLst>
          </p:cNvPr>
          <p:cNvSpPr txBox="1"/>
          <p:nvPr/>
        </p:nvSpPr>
        <p:spPr>
          <a:xfrm>
            <a:off x="374469" y="695449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CAFC48F-E748-1093-2788-72F1198CC61D}"/>
              </a:ext>
            </a:extLst>
          </p:cNvPr>
          <p:cNvSpPr txBox="1"/>
          <p:nvPr/>
        </p:nvSpPr>
        <p:spPr>
          <a:xfrm>
            <a:off x="3401" y="8425337"/>
            <a:ext cx="685459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5. Representative gating strategy for T cell cytokine secretion</a:t>
            </a:r>
            <a:endParaRPr lang="fi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gating strategies for paired comparisons between baseline REP TIL (BASELINE_48h) and unstimulated co-culture conditions (CO-CULTURE_48h) at 48h. CD4+ and CD8+ T cells are gated as in the Supplementary Figure 3 and from them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NF</a:t>
            </a:r>
            <a:r>
              <a:rPr lang="en-US" sz="800" dirty="0" err="1">
                <a:effectLst/>
                <a:latin typeface="Symbol" pitchFamily="2" charset="2"/>
                <a:ea typeface="Malgun Gothic" panose="020B0503020000020004" pitchFamily="34" charset="-127"/>
                <a:cs typeface="Times New Roman" panose="02020603050405020304" pitchFamily="18" charset="0"/>
              </a:rPr>
              <a:t>a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/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FN</a:t>
            </a:r>
            <a:r>
              <a:rPr lang="en-US" sz="800" dirty="0" err="1">
                <a:effectLst/>
                <a:latin typeface="Symbol" pitchFamily="2" charset="2"/>
                <a:ea typeface="Malgun Gothic" panose="020B0503020000020004" pitchFamily="34" charset="-127"/>
                <a:cs typeface="Times New Roman" panose="02020603050405020304" pitchFamily="18" charset="0"/>
              </a:rPr>
              <a:t>g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 cells are gated.</a:t>
            </a:r>
            <a:endParaRPr lang="fi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gating strategies for paired comparisons between co-culture conditions (CO-CULTURE_6h) and T-cell stimulated co-culture conditions (TSTIM_6h) at 6h. Gating done similarly as in panel A.</a:t>
            </a:r>
            <a:endParaRPr lang="fi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gating strategies for paired comparisons between co-culture conditions (CO-CULTURE_48h) and T-cell stimulated co-culture conditions (TSTIM_48h) at 48h. Gating done similarly as in panel A.</a:t>
            </a:r>
            <a:endParaRPr lang="fi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presentative gating strategies for paired comparisons in the expression of LAG-3 and PD-1 in baseline REP TILs (BASELINE_6h) and co-culture conditions (CO-CULTURE_6h) at 6h. CD4+ and CD8+ T cells are gated as in the Supplementary Figure 3 and from them LAG3+ and PD1+ cells are gated.</a:t>
            </a:r>
            <a:endParaRPr lang="fi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9435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03</TotalTime>
  <Words>203</Words>
  <Application>Microsoft Macintosh PowerPoint</Application>
  <PresentationFormat>A4-paperi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5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16:00Z</dcterms:modified>
</cp:coreProperties>
</file>